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318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639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559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258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6218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10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4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41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515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0692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463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8663A-BCA8-4C33-8FC4-400A2D1F02DE}" type="datetimeFigureOut">
              <a:rPr lang="en-GB" smtClean="0"/>
              <a:t>13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4F1CA-9D64-4DA1-895A-3C9A690B8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360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440180" y="4030980"/>
            <a:ext cx="9017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Video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20659" y="8100260"/>
            <a:ext cx="42841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1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.T induces actin remodelling with rich F-actin rings surrounding the infecting bacteria (magenta arrow) and inducing punctuated F-actin expression on the apical surface of infected cells (white arrow). Scale bar = 100 µm.</a:t>
            </a:r>
          </a:p>
        </p:txBody>
      </p:sp>
      <p:pic>
        <p:nvPicPr>
          <p:cNvPr id="6" name="WT z stack 2_8 h Factin_ZO1_DAPI x63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12000" contrast="37000"/>
          </a:blip>
          <a:stretch>
            <a:fillRect/>
          </a:stretch>
        </p:blipFill>
        <p:spPr>
          <a:xfrm>
            <a:off x="1440180" y="3954780"/>
            <a:ext cx="3684270" cy="3684270"/>
          </a:xfrm>
          <a:prstGeom prst="rect">
            <a:avLst/>
          </a:prstGeom>
        </p:spPr>
      </p:pic>
      <p:sp>
        <p:nvSpPr>
          <p:cNvPr id="9" name="Right Arrow 8"/>
          <p:cNvSpPr/>
          <p:nvPr/>
        </p:nvSpPr>
        <p:spPr>
          <a:xfrm rot="13279158">
            <a:off x="3661223" y="6592098"/>
            <a:ext cx="383568" cy="366068"/>
          </a:xfrm>
          <a:prstGeom prst="rightArrow">
            <a:avLst>
              <a:gd name="adj1" fmla="val 17308"/>
              <a:gd name="adj2" fmla="val 74257"/>
            </a:avLst>
          </a:prstGeom>
          <a:solidFill>
            <a:srgbClr val="FF66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ight Arrow 9"/>
          <p:cNvSpPr/>
          <p:nvPr/>
        </p:nvSpPr>
        <p:spPr>
          <a:xfrm rot="13279158">
            <a:off x="3411476" y="5147819"/>
            <a:ext cx="261936" cy="246382"/>
          </a:xfrm>
          <a:prstGeom prst="rightArrow">
            <a:avLst>
              <a:gd name="adj1" fmla="val 23399"/>
              <a:gd name="adj2" fmla="val 74257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/>
          <p:cNvSpPr txBox="1"/>
          <p:nvPr/>
        </p:nvSpPr>
        <p:spPr>
          <a:xfrm>
            <a:off x="1440180" y="3662541"/>
            <a:ext cx="368427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GB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-actin </a:t>
            </a:r>
            <a:r>
              <a:rPr lang="en-GB" dirty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en-GB" dirty="0" smtClean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endParaRPr lang="en-GB" dirty="0">
              <a:solidFill>
                <a:srgbClr val="24FF7B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440180" y="3970758"/>
            <a:ext cx="1038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deo 1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502712" y="7518605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73220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 mute="1">
                <p:cTn id="2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0</Words>
  <Application>Microsoft Office PowerPoint</Application>
  <PresentationFormat>Widescreen</PresentationFormat>
  <Paragraphs>4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1</cp:revision>
  <dcterms:created xsi:type="dcterms:W3CDTF">2023-07-13T17:30:29Z</dcterms:created>
  <dcterms:modified xsi:type="dcterms:W3CDTF">2023-07-13T17:34:27Z</dcterms:modified>
</cp:coreProperties>
</file>